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2426" autoAdjust="0"/>
    <p:restoredTop sz="94660"/>
  </p:normalViewPr>
  <p:slideViewPr>
    <p:cSldViewPr showGuides="1">
      <p:cViewPr>
        <p:scale>
          <a:sx n="100" d="100"/>
          <a:sy n="100" d="100"/>
        </p:scale>
        <p:origin x="-2088" y="-78"/>
      </p:cViewPr>
      <p:guideLst>
        <p:guide orient="horz" pos="5375"/>
        <p:guide pos="4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226210-E081-44F8-84E3-1DA22AAEFD7F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16AEF4-CE79-4333-8518-D9C3986F988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601724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16262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27951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55220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53150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81438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13109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59485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58987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34073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31194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70070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53080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9390" y="374446"/>
            <a:ext cx="2521524" cy="17871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643780" y="406494"/>
            <a:ext cx="2521524" cy="17939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2920" y="2386704"/>
            <a:ext cx="2521524" cy="17871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622494" y="2354059"/>
            <a:ext cx="2521524" cy="1800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9390" y="4333672"/>
            <a:ext cx="2528230" cy="1797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571029" y="4333672"/>
            <a:ext cx="2521524" cy="1797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2069" y="6314871"/>
            <a:ext cx="2538290" cy="1777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31329" y="8104534"/>
            <a:ext cx="64807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Key</a:t>
            </a:r>
            <a:r>
              <a:rPr lang="en-GB" sz="1200" dirty="0" smtClean="0"/>
              <a:t>:  Medium, uninfected control; Spent medium, </a:t>
            </a:r>
            <a:r>
              <a:rPr lang="en-GB" sz="1200" dirty="0" err="1" smtClean="0"/>
              <a:t>supernatent</a:t>
            </a:r>
            <a:r>
              <a:rPr lang="en-GB" sz="1200" dirty="0" smtClean="0"/>
              <a:t> from cultures.</a:t>
            </a:r>
          </a:p>
          <a:p>
            <a:r>
              <a:rPr lang="en-GB" sz="1200" dirty="0" smtClean="0"/>
              <a:t>A3 and A6, day 3 and day 6 samples from cultures in medium A (HOMEM + 10% FCS);</a:t>
            </a:r>
          </a:p>
          <a:p>
            <a:r>
              <a:rPr lang="en-GB" sz="1200" dirty="0" smtClean="0"/>
              <a:t>C3 and C6, day 3 and day 6 samples from cultures in medium C (</a:t>
            </a:r>
            <a:r>
              <a:rPr lang="en-GB" sz="1200" dirty="0" err="1" smtClean="0"/>
              <a:t>mHomem</a:t>
            </a:r>
            <a:r>
              <a:rPr lang="en-GB" sz="1200" dirty="0" smtClean="0"/>
              <a:t> + 10% FCS).</a:t>
            </a:r>
          </a:p>
        </p:txBody>
      </p:sp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596945" y="6306488"/>
            <a:ext cx="2518171" cy="17939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472920" y="37162"/>
            <a:ext cx="4633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S10 Fig. </a:t>
            </a:r>
            <a:r>
              <a:rPr lang="en-GB" b="1" dirty="0" err="1" smtClean="0"/>
              <a:t>Metabolomic</a:t>
            </a:r>
            <a:r>
              <a:rPr lang="en-GB" b="1" dirty="0" smtClean="0"/>
              <a:t> analysis of spent </a:t>
            </a:r>
            <a:r>
              <a:rPr lang="en-GB" b="1" dirty="0" smtClean="0"/>
              <a:t>media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xmlns="" val="12902433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7</TotalTime>
  <Words>67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eth Westrop</dc:creator>
  <cp:lastModifiedBy>Graham Coombs</cp:lastModifiedBy>
  <cp:revision>34</cp:revision>
  <dcterms:created xsi:type="dcterms:W3CDTF">2015-04-30T15:02:01Z</dcterms:created>
  <dcterms:modified xsi:type="dcterms:W3CDTF">2015-08-19T08:55:55Z</dcterms:modified>
</cp:coreProperties>
</file>